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315200" cy="96012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9" d="100"/>
          <a:sy n="49" d="100"/>
        </p:scale>
        <p:origin x="-1518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6516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25918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8860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31546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91498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343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7331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13179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67545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44874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56302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61D97-83EC-4785-9CD2-FF9D1C01F06A}" type="datetimeFigureOut">
              <a:rPr lang="en-CA" smtClean="0"/>
              <a:t>27/02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9BAA0-C62A-475A-BD1F-D6EBF4AC3F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8482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microsoft.com/office/2007/relationships/hdphoto" Target="../media/hdphoto3.wdp"/><Relationship Id="rId18" Type="http://schemas.microsoft.com/office/2007/relationships/hdphoto" Target="../media/hdphoto5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9.jpeg"/><Relationship Id="rId17" Type="http://schemas.openxmlformats.org/officeDocument/2006/relationships/image" Target="../media/image12.jpeg"/><Relationship Id="rId2" Type="http://schemas.openxmlformats.org/officeDocument/2006/relationships/image" Target="../media/image1.png"/><Relationship Id="rId16" Type="http://schemas.microsoft.com/office/2007/relationships/hdphoto" Target="../media/hdphoto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2.wdp"/><Relationship Id="rId5" Type="http://schemas.openxmlformats.org/officeDocument/2006/relationships/image" Target="../media/image4.png"/><Relationship Id="rId15" Type="http://schemas.openxmlformats.org/officeDocument/2006/relationships/image" Target="../media/image11.jpeg"/><Relationship Id="rId10" Type="http://schemas.openxmlformats.org/officeDocument/2006/relationships/image" Target="../media/image8.jpeg"/><Relationship Id="rId4" Type="http://schemas.openxmlformats.org/officeDocument/2006/relationships/image" Target="../media/image3.png"/><Relationship Id="rId9" Type="http://schemas.microsoft.com/office/2007/relationships/hdphoto" Target="../media/hdphoto1.wdp"/><Relationship Id="rId14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492583" y="487352"/>
            <a:ext cx="6151288" cy="8557819"/>
            <a:chOff x="492583" y="487352"/>
            <a:chExt cx="6151288" cy="8557819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21805" y="627226"/>
              <a:ext cx="1695313" cy="14523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7890" y="1907369"/>
              <a:ext cx="1695313" cy="14523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82526" y="6060517"/>
              <a:ext cx="1708647" cy="14638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21805" y="3275856"/>
              <a:ext cx="1769368" cy="15158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1231888" y="3190479"/>
              <a:ext cx="12618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err="1" smtClean="0">
                  <a:latin typeface="Arial" pitchFamily="34" charset="0"/>
                  <a:cs typeface="Arial" pitchFamily="34" charset="0"/>
                </a:rPr>
                <a:t>HeLa</a:t>
              </a:r>
              <a:r>
                <a:rPr lang="en-CA" dirty="0" smtClean="0">
                  <a:latin typeface="Arial" pitchFamily="34" charset="0"/>
                  <a:cs typeface="Arial" pitchFamily="34" charset="0"/>
                </a:rPr>
                <a:t> cells</a:t>
              </a:r>
              <a:endParaRPr lang="en-CA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492583" y="899592"/>
              <a:ext cx="739305" cy="709047"/>
              <a:chOff x="101131" y="899592"/>
              <a:chExt cx="739305" cy="709047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101131" y="899592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Thomas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55019" y="1331640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Sham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920907" y="8532440"/>
              <a:ext cx="40831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Background 1 min     15 min     30 min    45 min    60 min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52165" y="4720150"/>
              <a:ext cx="1769368" cy="15158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1280947" y="487352"/>
              <a:ext cx="2108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>
                  <a:latin typeface="Arial" pitchFamily="34" charset="0"/>
                  <a:cs typeface="Arial" pitchFamily="34" charset="0"/>
                </a:rPr>
                <a:t>MDA-MB-231 cells</a:t>
              </a:r>
              <a:endParaRPr lang="en-CA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280947" y="1832741"/>
              <a:ext cx="14157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>
                  <a:latin typeface="Arial" pitchFamily="34" charset="0"/>
                  <a:cs typeface="Arial" pitchFamily="34" charset="0"/>
                </a:rPr>
                <a:t>MCF-7 cells</a:t>
              </a:r>
              <a:endParaRPr lang="en-CA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208939" y="5940152"/>
              <a:ext cx="12105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>
                  <a:latin typeface="Arial" pitchFamily="34" charset="0"/>
                  <a:cs typeface="Arial" pitchFamily="34" charset="0"/>
                </a:rPr>
                <a:t>HSG cells</a:t>
              </a:r>
              <a:endParaRPr lang="en-CA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95860" y="7440093"/>
              <a:ext cx="1695313" cy="14523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6" name="TextBox 35"/>
            <p:cNvSpPr txBox="1"/>
            <p:nvPr/>
          </p:nvSpPr>
          <p:spPr>
            <a:xfrm>
              <a:off x="1136931" y="7236296"/>
              <a:ext cx="1569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>
                  <a:latin typeface="Arial" pitchFamily="34" charset="0"/>
                  <a:cs typeface="Arial" pitchFamily="34" charset="0"/>
                </a:rPr>
                <a:t>HEK293 cells</a:t>
              </a:r>
              <a:endParaRPr lang="en-CA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5786425" y="4529138"/>
              <a:ext cx="14686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Fluorescence increase</a:t>
              </a:r>
              <a:endParaRPr lang="en-CA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836554" y="8798950"/>
              <a:ext cx="4267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time</a:t>
              </a:r>
              <a:endParaRPr lang="en-CA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8939" y="795129"/>
              <a:ext cx="3709808" cy="968559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8939" y="2159680"/>
              <a:ext cx="3709808" cy="97216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8939" y="6267737"/>
              <a:ext cx="3709808" cy="968559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8939" y="7575447"/>
              <a:ext cx="3709808" cy="97096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93029" y="3563888"/>
              <a:ext cx="3709808" cy="970959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8454" y="4969778"/>
              <a:ext cx="3704191" cy="970374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1185354" y="4662001"/>
              <a:ext cx="1620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 smtClean="0">
                  <a:latin typeface="Arial" pitchFamily="34" charset="0"/>
                  <a:cs typeface="Arial" pitchFamily="34" charset="0"/>
                </a:rPr>
                <a:t>HBL-100 cells</a:t>
              </a:r>
              <a:endParaRPr lang="en-CA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492583" y="2278777"/>
              <a:ext cx="739305" cy="698014"/>
              <a:chOff x="101131" y="934026"/>
              <a:chExt cx="739305" cy="698014"/>
            </a:xfrm>
          </p:grpSpPr>
          <p:sp>
            <p:nvSpPr>
              <p:cNvPr id="38" name="TextBox 37"/>
              <p:cNvSpPr txBox="1"/>
              <p:nvPr/>
            </p:nvSpPr>
            <p:spPr>
              <a:xfrm>
                <a:off x="101131" y="934026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Thomas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55019" y="1355041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Sham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492583" y="3635896"/>
              <a:ext cx="739305" cy="815261"/>
              <a:chOff x="101131" y="828082"/>
              <a:chExt cx="739305" cy="815261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101131" y="828082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Thomas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55019" y="1366344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Sham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3" name="Group 42"/>
            <p:cNvGrpSpPr/>
            <p:nvPr/>
          </p:nvGrpSpPr>
          <p:grpSpPr>
            <a:xfrm>
              <a:off x="492583" y="5076056"/>
              <a:ext cx="739305" cy="709047"/>
              <a:chOff x="101131" y="922100"/>
              <a:chExt cx="739305" cy="709047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101131" y="922100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Thomas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255019" y="1354148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Sham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492583" y="6383233"/>
              <a:ext cx="739305" cy="770022"/>
              <a:chOff x="101131" y="932226"/>
              <a:chExt cx="739305" cy="770022"/>
            </a:xfrm>
          </p:grpSpPr>
          <p:sp>
            <p:nvSpPr>
              <p:cNvPr id="47" name="TextBox 46"/>
              <p:cNvSpPr txBox="1"/>
              <p:nvPr/>
            </p:nvSpPr>
            <p:spPr>
              <a:xfrm>
                <a:off x="101131" y="932226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Thomas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255019" y="1425249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Sham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492583" y="7705720"/>
              <a:ext cx="739305" cy="737565"/>
              <a:chOff x="101131" y="945802"/>
              <a:chExt cx="739305" cy="737565"/>
            </a:xfrm>
          </p:grpSpPr>
          <p:sp>
            <p:nvSpPr>
              <p:cNvPr id="50" name="TextBox 49"/>
              <p:cNvSpPr txBox="1"/>
              <p:nvPr/>
            </p:nvSpPr>
            <p:spPr>
              <a:xfrm>
                <a:off x="101131" y="945802"/>
                <a:ext cx="7393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Thomas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55019" y="1406368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1200" dirty="0" smtClean="0">
                    <a:latin typeface="Arial" pitchFamily="34" charset="0"/>
                    <a:cs typeface="Arial" pitchFamily="34" charset="0"/>
                  </a:rPr>
                  <a:t>Sham</a:t>
                </a:r>
                <a:endParaRPr lang="en-CA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52073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8"/>
  <p:tag name="MMPROD_UIDATA" val="&lt;database version=&quot;6.0&quot;&gt;&lt;object type=&quot;1&quot; unique_id=&quot;10001&quot;&gt;&lt;object type=&quot;8&quot; unique_id=&quot;10027&quot;&gt;&lt;/object&gt;&lt;object type=&quot;2&quot; unique_id=&quot;10028&quot;&gt;&lt;object type=&quot;3&quot; unique_id=&quot;10029&quot;&gt;&lt;property id=&quot;20148&quot; value=&quot;5&quot;/&gt;&lt;property id=&quot;20300&quot; value=&quot;Slide 1&quot;/&gt;&lt;property id=&quot;20307&quot; value=&quot;257&quot;/&gt;&lt;/object&gt;&lt;/object&gt;&lt;/object&gt;&lt;/database&gt;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alth Sciences North - Horizon Santé-N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lafrenie</dc:creator>
  <cp:lastModifiedBy>rlafrenie</cp:lastModifiedBy>
  <cp:revision>2</cp:revision>
  <cp:lastPrinted>2015-02-27T16:19:04Z</cp:lastPrinted>
  <dcterms:created xsi:type="dcterms:W3CDTF">2015-02-27T16:16:37Z</dcterms:created>
  <dcterms:modified xsi:type="dcterms:W3CDTF">2015-02-27T16:19:19Z</dcterms:modified>
</cp:coreProperties>
</file>